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338" y="-7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5678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34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2588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9931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0352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6554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3661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1445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1627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445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399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D6D9C-3883-434D-BAAA-2ADC16B8B789}" type="datetimeFigureOut">
              <a:rPr lang="fr-FR" smtClean="0"/>
              <a:t>28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0ECA9-CBB2-4581-A1E0-216D617FCCF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746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e 17"/>
          <p:cNvGrpSpPr/>
          <p:nvPr/>
        </p:nvGrpSpPr>
        <p:grpSpPr>
          <a:xfrm>
            <a:off x="-15552" y="-99392"/>
            <a:ext cx="9921552" cy="6984776"/>
            <a:chOff x="-15552" y="-99392"/>
            <a:chExt cx="9921552" cy="6984776"/>
          </a:xfrm>
        </p:grpSpPr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933056"/>
              <a:ext cx="5029200" cy="2723198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119750"/>
              <a:ext cx="5029200" cy="2723198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-27384"/>
              <a:ext cx="5029200" cy="2723198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5025008" y="2780928"/>
              <a:ext cx="4592960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fr-FR" sz="1600" dirty="0" err="1"/>
                <a:t>Additional</a:t>
              </a:r>
              <a:r>
                <a:rPr lang="fr-FR" sz="1600" dirty="0"/>
                <a:t> file 1 </a:t>
              </a:r>
              <a:r>
                <a:rPr lang="fr-FR" sz="1600" dirty="0" smtClean="0"/>
                <a:t>– </a:t>
              </a:r>
              <a:r>
                <a:rPr lang="en-US" sz="1600" dirty="0"/>
                <a:t>Rarefaction curves of OTU richness of each sample from the experimental groups, computed after normalization to 11599 reads per sample.</a:t>
              </a:r>
              <a:endParaRPr lang="en-GB" sz="1600" dirty="0"/>
            </a:p>
          </p:txBody>
        </p:sp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76800" y="-27384"/>
              <a:ext cx="5029200" cy="2723198"/>
            </a:xfrm>
            <a:prstGeom prst="rect">
              <a:avLst/>
            </a:prstGeom>
          </p:spPr>
        </p:pic>
        <p:sp>
          <p:nvSpPr>
            <p:cNvPr id="4" name="ZoneTexte 3"/>
            <p:cNvSpPr txBox="1"/>
            <p:nvPr/>
          </p:nvSpPr>
          <p:spPr>
            <a:xfrm>
              <a:off x="5169024" y="354142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LH1-LH2</a:t>
              </a:r>
              <a:endParaRPr lang="fr-FR" sz="1600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7113240" y="6623774"/>
              <a:ext cx="5760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 smtClean="0"/>
                <a:t>Reads</a:t>
              </a:r>
              <a:endParaRPr lang="fr-FR" sz="1100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4880992" y="-99392"/>
              <a:ext cx="5040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 smtClean="0"/>
                <a:t>OTUs</a:t>
              </a:r>
              <a:endParaRPr lang="fr-FR" sz="1100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2216696" y="6623774"/>
              <a:ext cx="5760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 smtClean="0"/>
                <a:t>Reads</a:t>
              </a:r>
              <a:endParaRPr lang="fr-FR" sz="11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-15552" y="-99392"/>
              <a:ext cx="5040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 smtClean="0"/>
                <a:t>OTUs</a:t>
              </a:r>
              <a:endParaRPr lang="fr-FR" sz="11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44488" y="332656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C1-LH2</a:t>
              </a:r>
              <a:endParaRPr lang="fr-FR" sz="16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344488" y="2946430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C1-C2</a:t>
              </a:r>
              <a:endParaRPr lang="fr-FR" sz="1600" dirty="0"/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344488" y="4890646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C1-HG2</a:t>
              </a:r>
              <a:endParaRPr lang="fr-FR" sz="1600" dirty="0"/>
            </a:p>
          </p:txBody>
        </p:sp>
        <p:pic>
          <p:nvPicPr>
            <p:cNvPr id="16" name="Image 1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76800" y="3946162"/>
              <a:ext cx="5029200" cy="2723198"/>
            </a:xfrm>
            <a:prstGeom prst="rect">
              <a:avLst/>
            </a:prstGeom>
          </p:spPr>
        </p:pic>
        <p:sp>
          <p:nvSpPr>
            <p:cNvPr id="17" name="ZoneTexte 16"/>
            <p:cNvSpPr txBox="1"/>
            <p:nvPr/>
          </p:nvSpPr>
          <p:spPr>
            <a:xfrm>
              <a:off x="5169024" y="4314582"/>
              <a:ext cx="10081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 smtClean="0"/>
                <a:t>HG1-HG2</a:t>
              </a:r>
              <a:endParaRPr lang="fr-FR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3556252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35</Words>
  <Application>Microsoft Office PowerPoint</Application>
  <PresentationFormat>Format A4 (210 x 297 mm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el Gatesoupe</dc:creator>
  <cp:lastModifiedBy>Joel GATESOUPE</cp:lastModifiedBy>
  <cp:revision>11</cp:revision>
  <cp:lastPrinted>2016-06-17T11:24:16Z</cp:lastPrinted>
  <dcterms:created xsi:type="dcterms:W3CDTF">2016-05-19T13:37:36Z</dcterms:created>
  <dcterms:modified xsi:type="dcterms:W3CDTF">2016-10-28T13:36:34Z</dcterms:modified>
</cp:coreProperties>
</file>